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A42E78-F34F-46E5-8CFF-39404C929F8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C9F0FF-8FDD-459A-9FFC-8D6D508AC0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5AB822-2CA2-4A1F-9283-F29826F12E3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DF2AF-31C0-4243-84F9-B72706352AF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A47313-CC45-41B3-BFB3-FC4D7E2BAF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1BAAD8-44E1-4E02-8EC9-A3BFE67B01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E6F012-1ED4-4C02-B404-5412629069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2C9F08-CEB9-4343-8545-F947C154FA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731D30-6753-4729-859A-B5A0162EEF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C1E784-8D08-43B7-B00E-05C58242EC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8F6F5-D1CE-4356-AC4F-E10CA9C3BE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F7829F-368C-4B2E-9FC8-C26CBB8453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EB6CA2-B084-4988-9974-A4443328305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85800" y="457200"/>
            <a:ext cx="18432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609480" y="1371600"/>
          <a:ext cx="3581640" cy="35812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09480" y="1371600"/>
                    <a:ext cx="3581640" cy="3581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4" name=""/>
          <p:cNvGraphicFramePr/>
          <p:nvPr/>
        </p:nvGraphicFramePr>
        <p:xfrm>
          <a:off x="4495680" y="1447920"/>
          <a:ext cx="3708360" cy="36352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5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495680" y="1447920"/>
                    <a:ext cx="3708360" cy="3635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6" name=""/>
          <p:cNvSpPr/>
          <p:nvPr/>
        </p:nvSpPr>
        <p:spPr>
          <a:xfrm>
            <a:off x="229320" y="380880"/>
            <a:ext cx="90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 S1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99440" y="5025960"/>
            <a:ext cx="84056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Neutralizing antibody to IFN-</a:t>
            </a: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(clone R46A2, 100ug/mouse/day) was administered ip from d10-d20 afte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immunization with collagen and CFA. Rat IgG was used as isotype control. The control group did not receiv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ny antibody. Splenocytes and single cell suspension of draining inguinal lymph nodes from day 20 were culture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for 5 days in the presence of collagen rechallenge. Supernatants were analyzed for IL-17 by ELIS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4648320" y="1219320"/>
          <a:ext cx="3708360" cy="39243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648320" y="1219320"/>
                    <a:ext cx="3708360" cy="3924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"/>
          <p:cNvSpPr/>
          <p:nvPr/>
        </p:nvSpPr>
        <p:spPr>
          <a:xfrm>
            <a:off x="306360" y="380880"/>
            <a:ext cx="90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01960" y="5562720"/>
            <a:ext cx="891180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Neutralizing antibody to IFN-</a:t>
            </a: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(clone R46A2, 100ug/mouse/day), and/or neutralizing antibody to IL-4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(clone 11B11, 100ug/mouse/day) was administered ip from d10-d20 after immunization with collagen and CFA. Rat Ig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was used as isotype control. The control group did not receive any antibody. Splenocytes from day 20 were cultured fo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5 days in the presence of collagen rechallenge. Supernatants were analyzed for IL-17 and IFN-</a:t>
            </a: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by ELIS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2" name=""/>
          <p:cNvGraphicFramePr/>
          <p:nvPr/>
        </p:nvGraphicFramePr>
        <p:xfrm>
          <a:off x="533520" y="1066680"/>
          <a:ext cx="3816360" cy="41403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3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33520" y="1066680"/>
                    <a:ext cx="3816360" cy="4140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21T21:43:47Z</dcterms:created>
  <dc:creator>sarkar</dc:creator>
  <dc:description/>
  <dc:language>en-US</dc:language>
  <cp:lastModifiedBy>sarkar</cp:lastModifiedBy>
  <dcterms:modified xsi:type="dcterms:W3CDTF">2009-10-15T18:01:42Z</dcterms:modified>
  <cp:revision>14</cp:revision>
  <dc:subject/>
  <dc:title>Slide 1</dc:title>
</cp:coreProperties>
</file>